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5" r:id="rId30"/>
    <p:sldId id="286" r:id="rId31"/>
    <p:sldId id="287" r:id="rId32"/>
    <p:sldId id="288" r:id="rId33"/>
    <p:sldId id="289" r:id="rId34"/>
    <p:sldId id="290" r:id="rId35"/>
    <p:sldId id="291" r:id="rId36"/>
    <p:sldId id="292" r:id="rId37"/>
    <p:sldId id="293" r:id="rId38"/>
    <p:sldId id="294" r:id="rId39"/>
    <p:sldId id="295" r:id="rId40"/>
  </p:sldIdLst>
  <p:sldSz cx="12192000" cy="6858000"/>
  <p:notesSz cx="6858000" cy="9144000"/>
  <p:photoAlbum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95B0D1-EF6F-4FCF-A1BB-697AAB3FEB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5356D0-694F-4546-9B4D-744F691FB5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F67D38-408C-4213-A6F9-C2C9FD263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E2F24-3D84-403E-9AA7-889E092A0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4844FA-9715-4417-8E6C-34CE99F35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8176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CCB81-BACE-4DD7-B788-51CE1C6DC6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63C93A-D1CF-48CC-BE4A-D341CD7A39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C39606-CD45-45D8-BF09-70422DEB0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046D7C-D34E-4035-A066-76E502893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6FEBA-3D89-4333-A90E-08388D154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4592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FFD064-9F88-4534-BFB1-129CD55947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B3D13E-CB00-4A90-BD49-AF0B99E1DE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87D93-FEE9-480C-85EC-0AE9D4943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1643B-24C7-4A00-9014-82CD16F59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1AB7F-E0CF-41F5-93FC-BFA0A02A9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1196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84E09C-5062-4A26-B8F8-609E814B49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577F8F-20C5-4CA0-88F3-E80AD8AF9D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A5E911-DFCF-4FC8-982F-61FDDC723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06D667-2103-4B27-8DB1-D0E89A8DF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1B85C-16E7-4E45-A94A-7FDDE6454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315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FE9C7-9957-41A8-BF28-850D8283D7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B705A1-91E9-4C6A-B1E9-45707D6A19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B0F95-AD50-4D83-8BD1-64F0BDC52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B6B07C-B114-440F-83CC-BB0D6D22A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798025-F1DD-4FCA-89E6-A5AC13DF7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1816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3D17E-799E-4E46-AB45-D42F6E8E52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D892EC-B4C9-40A9-AB1D-52A78A8FC7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DFB375-1074-4665-AC46-80A2379002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EF90F8-CD9C-49CC-B9A7-CF1574B39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D09C29-99CC-4935-89C5-2AD0FDC0B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F0076-E61C-4456-B5BA-106188EE3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624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C9FD13-0457-4592-AF23-490BE6DDA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5565B9-B325-4D87-87D9-7F81DD106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26C0BD-4A27-4A47-A2E2-B986761949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5EDEFE-49DB-4180-AFAB-3D0B54409D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8AAE72-9B18-4F32-9DED-B30DA732BA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55581A-6C25-40F8-B47E-3F271E09C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0C9464-E331-4EF2-877E-72A81BE77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BC6F36-ECF9-4418-B5EE-937BF1FF5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4908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198D3-1D9E-4756-81F4-E531209C8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C10C37-E367-42BA-91C4-E07E613BC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4E50D4-1D5D-4540-9A83-7ED97A500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805408-37AB-46A9-B4C5-5C6B028821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0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87583-8A86-4BE4-A0DD-42B9825E9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B7DB19-BF08-4C89-A93D-A673EB968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801F12-34C1-4851-9256-D8B71AE31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839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2EF26-20A4-434A-BAF8-1E142F7B9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0D1147-C52D-490C-B259-E2E8C5F2A4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81820F-1C50-4A14-B8CF-D205582644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1B62E0-FF4D-420A-A30D-85931764D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ADDD16-9237-45A3-81AD-D5B2EFAE8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44C422-48EF-4F10-8190-4755DDB49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2498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F2257-7A51-4B26-8BA4-3015B5714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1013C7-D44D-4BE0-BE53-C4720D4A4C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BAAC17-EB13-462D-AC74-0FAFB64206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475F0-792A-478E-9C9C-EF6A9466B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ECD190-5985-4A49-B17B-DC66F2521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F3545-1A56-4C77-8B2A-530B4A6C1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58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2823A5-9692-4532-9F27-98A43CE2E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8C37CF-1B44-49DF-A1C6-966178F355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5F975D-E537-4E4D-A1CE-A321B81565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526B7-D1B3-4769-BD75-00A4398CCE9C}" type="datetimeFigureOut">
              <a:rPr lang="en-GB" smtClean="0"/>
              <a:t>10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6D5675-C2E5-4980-A61D-D851D95B9B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46768-B14C-46FC-BCC9-4B6DB16586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0D49D-4818-4A8E-B5FA-8FD4BB686BB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8627823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2A">
            <a:extLst>
              <a:ext uri="{FF2B5EF4-FFF2-40B4-BE49-F238E27FC236}">
                <a16:creationId xmlns:a16="http://schemas.microsoft.com/office/drawing/2014/main" id="{723A468A-12C3-47F2-8EA2-ED4D7018C07C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9250"/>
            <a:ext cx="12192000" cy="615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34881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4B">
            <a:extLst>
              <a:ext uri="{FF2B5EF4-FFF2-40B4-BE49-F238E27FC236}">
                <a16:creationId xmlns:a16="http://schemas.microsoft.com/office/drawing/2014/main" id="{CA3C92AC-650D-4F78-B873-F9173D3C4AE9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925"/>
            <a:ext cx="12192000" cy="6786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0766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4C">
            <a:extLst>
              <a:ext uri="{FF2B5EF4-FFF2-40B4-BE49-F238E27FC236}">
                <a16:creationId xmlns:a16="http://schemas.microsoft.com/office/drawing/2014/main" id="{DE0E7D48-0341-4D50-BB6C-639A9829245A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13" y="0"/>
            <a:ext cx="120665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24568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4D">
            <a:extLst>
              <a:ext uri="{FF2B5EF4-FFF2-40B4-BE49-F238E27FC236}">
                <a16:creationId xmlns:a16="http://schemas.microsoft.com/office/drawing/2014/main" id="{FFC10755-2A31-4410-8D21-E03E1C0C3258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813"/>
            <a:ext cx="12192000" cy="6810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30815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5A">
            <a:extLst>
              <a:ext uri="{FF2B5EF4-FFF2-40B4-BE49-F238E27FC236}">
                <a16:creationId xmlns:a16="http://schemas.microsoft.com/office/drawing/2014/main" id="{8B12B274-C56B-4BD5-973B-0AADF6427C38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9250"/>
            <a:ext cx="12192000" cy="615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12439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5B">
            <a:extLst>
              <a:ext uri="{FF2B5EF4-FFF2-40B4-BE49-F238E27FC236}">
                <a16:creationId xmlns:a16="http://schemas.microsoft.com/office/drawing/2014/main" id="{81253A9D-A0B5-477D-A7E0-8A860B0070BE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75"/>
            <a:ext cx="12192000" cy="6851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551837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5C">
            <a:extLst>
              <a:ext uri="{FF2B5EF4-FFF2-40B4-BE49-F238E27FC236}">
                <a16:creationId xmlns:a16="http://schemas.microsoft.com/office/drawing/2014/main" id="{23520F0B-FF06-48E3-97D0-7FF968F0AA69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913"/>
            <a:ext cx="12192000" cy="6732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366326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5D">
            <a:extLst>
              <a:ext uri="{FF2B5EF4-FFF2-40B4-BE49-F238E27FC236}">
                <a16:creationId xmlns:a16="http://schemas.microsoft.com/office/drawing/2014/main" id="{159620FE-F26B-4396-9BC3-D6196234F970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7188"/>
            <a:ext cx="12192000" cy="6142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534388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6A">
            <a:extLst>
              <a:ext uri="{FF2B5EF4-FFF2-40B4-BE49-F238E27FC236}">
                <a16:creationId xmlns:a16="http://schemas.microsoft.com/office/drawing/2014/main" id="{A9391237-29E6-4D68-8ECA-1B86C96101A2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4788"/>
            <a:ext cx="12192000" cy="6448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626793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6B">
            <a:extLst>
              <a:ext uri="{FF2B5EF4-FFF2-40B4-BE49-F238E27FC236}">
                <a16:creationId xmlns:a16="http://schemas.microsoft.com/office/drawing/2014/main" id="{AD32B940-B682-44AB-B692-2104129712AF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" y="0"/>
            <a:ext cx="12180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939921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6C">
            <a:extLst>
              <a:ext uri="{FF2B5EF4-FFF2-40B4-BE49-F238E27FC236}">
                <a16:creationId xmlns:a16="http://schemas.microsoft.com/office/drawing/2014/main" id="{80080866-4220-4291-A8E6-BEC4DBD0D935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3" y="0"/>
            <a:ext cx="1218088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5101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2B">
            <a:extLst>
              <a:ext uri="{FF2B5EF4-FFF2-40B4-BE49-F238E27FC236}">
                <a16:creationId xmlns:a16="http://schemas.microsoft.com/office/drawing/2014/main" id="{CDAE8987-2C12-4649-B687-2264D2B32434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75" y="0"/>
            <a:ext cx="120078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431963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6D">
            <a:extLst>
              <a:ext uri="{FF2B5EF4-FFF2-40B4-BE49-F238E27FC236}">
                <a16:creationId xmlns:a16="http://schemas.microsoft.com/office/drawing/2014/main" id="{1EB76073-A066-40B6-8A96-2CDD0CE906D0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3525"/>
            <a:ext cx="12192000" cy="6330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907666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7A">
            <a:extLst>
              <a:ext uri="{FF2B5EF4-FFF2-40B4-BE49-F238E27FC236}">
                <a16:creationId xmlns:a16="http://schemas.microsoft.com/office/drawing/2014/main" id="{F7593006-81CE-46C0-9079-388981AACD98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5088"/>
            <a:ext cx="12192000" cy="6727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722177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7B">
            <a:extLst>
              <a:ext uri="{FF2B5EF4-FFF2-40B4-BE49-F238E27FC236}">
                <a16:creationId xmlns:a16="http://schemas.microsoft.com/office/drawing/2014/main" id="{0DFA3A57-9E36-4164-ADD7-29710AF59123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9550"/>
            <a:ext cx="12192000" cy="64373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41753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7C">
            <a:extLst>
              <a:ext uri="{FF2B5EF4-FFF2-40B4-BE49-F238E27FC236}">
                <a16:creationId xmlns:a16="http://schemas.microsoft.com/office/drawing/2014/main" id="{8C01846F-A0FA-4BC2-BB25-4D9A84B84FE8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0825"/>
            <a:ext cx="12192000" cy="6356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53161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8A">
            <a:extLst>
              <a:ext uri="{FF2B5EF4-FFF2-40B4-BE49-F238E27FC236}">
                <a16:creationId xmlns:a16="http://schemas.microsoft.com/office/drawing/2014/main" id="{BC4803C5-6D92-4DC1-A427-5AF091CB11C5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1763"/>
            <a:ext cx="12192000" cy="6592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326107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8B">
            <a:extLst>
              <a:ext uri="{FF2B5EF4-FFF2-40B4-BE49-F238E27FC236}">
                <a16:creationId xmlns:a16="http://schemas.microsoft.com/office/drawing/2014/main" id="{902318E3-CAC5-4599-A2E9-94EC5C59A6EB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8925"/>
            <a:ext cx="12192000" cy="6278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41003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8C">
            <a:extLst>
              <a:ext uri="{FF2B5EF4-FFF2-40B4-BE49-F238E27FC236}">
                <a16:creationId xmlns:a16="http://schemas.microsoft.com/office/drawing/2014/main" id="{EF9B5616-C3AA-4861-AC6E-FF2B6EE0DEB6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2575"/>
            <a:ext cx="12192000" cy="6291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8006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8D">
            <a:extLst>
              <a:ext uri="{FF2B5EF4-FFF2-40B4-BE49-F238E27FC236}">
                <a16:creationId xmlns:a16="http://schemas.microsoft.com/office/drawing/2014/main" id="{95A90F6B-63A2-4465-A074-C0DB1E6DCA92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6050"/>
            <a:ext cx="12192000" cy="656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58689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9A">
            <a:extLst>
              <a:ext uri="{FF2B5EF4-FFF2-40B4-BE49-F238E27FC236}">
                <a16:creationId xmlns:a16="http://schemas.microsoft.com/office/drawing/2014/main" id="{36781397-448A-4AD9-ACA5-40BD66B3CC71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1788"/>
            <a:ext cx="12192000" cy="6194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713641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9B">
            <a:extLst>
              <a:ext uri="{FF2B5EF4-FFF2-40B4-BE49-F238E27FC236}">
                <a16:creationId xmlns:a16="http://schemas.microsoft.com/office/drawing/2014/main" id="{C3CE51A0-47F8-4102-8CA4-49AEB1F93807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7000"/>
            <a:ext cx="12192000" cy="6602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5213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2C">
            <a:extLst>
              <a:ext uri="{FF2B5EF4-FFF2-40B4-BE49-F238E27FC236}">
                <a16:creationId xmlns:a16="http://schemas.microsoft.com/office/drawing/2014/main" id="{2835E72E-B4A8-43E5-B04E-735654521097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5763"/>
            <a:ext cx="12192000" cy="6084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204335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9C">
            <a:extLst>
              <a:ext uri="{FF2B5EF4-FFF2-40B4-BE49-F238E27FC236}">
                <a16:creationId xmlns:a16="http://schemas.microsoft.com/office/drawing/2014/main" id="{3CCAE851-E55E-46E4-8AA7-562A1027825C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1438"/>
            <a:ext cx="12192000" cy="6715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09845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9D">
            <a:extLst>
              <a:ext uri="{FF2B5EF4-FFF2-40B4-BE49-F238E27FC236}">
                <a16:creationId xmlns:a16="http://schemas.microsoft.com/office/drawing/2014/main" id="{5F22F260-F454-4ED6-9327-1D4F629F0370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4950"/>
            <a:ext cx="12192000" cy="6386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17288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0A">
            <a:extLst>
              <a:ext uri="{FF2B5EF4-FFF2-40B4-BE49-F238E27FC236}">
                <a16:creationId xmlns:a16="http://schemas.microsoft.com/office/drawing/2014/main" id="{832E47B3-6DB3-475F-BF53-D71BE2C85483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"/>
            <a:ext cx="12192000" cy="6457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509061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0B">
            <a:extLst>
              <a:ext uri="{FF2B5EF4-FFF2-40B4-BE49-F238E27FC236}">
                <a16:creationId xmlns:a16="http://schemas.microsoft.com/office/drawing/2014/main" id="{A08FB51E-990F-4C41-9F7B-A837CAE86639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3363"/>
            <a:ext cx="12192000" cy="6391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654524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0C">
            <a:extLst>
              <a:ext uri="{FF2B5EF4-FFF2-40B4-BE49-F238E27FC236}">
                <a16:creationId xmlns:a16="http://schemas.microsoft.com/office/drawing/2014/main" id="{E01AB415-36DB-4A58-9B2E-C93AC1D2E005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6063"/>
            <a:ext cx="12192000" cy="6365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977478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0D">
            <a:extLst>
              <a:ext uri="{FF2B5EF4-FFF2-40B4-BE49-F238E27FC236}">
                <a16:creationId xmlns:a16="http://schemas.microsoft.com/office/drawing/2014/main" id="{25F35BDC-9B3E-45D3-B89E-5CAD60F79D98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9238"/>
            <a:ext cx="12192000" cy="6359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702709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1A">
            <a:extLst>
              <a:ext uri="{FF2B5EF4-FFF2-40B4-BE49-F238E27FC236}">
                <a16:creationId xmlns:a16="http://schemas.microsoft.com/office/drawing/2014/main" id="{F9C51ED5-44BE-4118-A1FD-C755CEA70A66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3988"/>
            <a:ext cx="12192000" cy="6548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13212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1B">
            <a:extLst>
              <a:ext uri="{FF2B5EF4-FFF2-40B4-BE49-F238E27FC236}">
                <a16:creationId xmlns:a16="http://schemas.microsoft.com/office/drawing/2014/main" id="{020B8A1A-4D50-4F57-8F9A-727F4ACC8AEE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3" y="0"/>
            <a:ext cx="121570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874108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1C">
            <a:extLst>
              <a:ext uri="{FF2B5EF4-FFF2-40B4-BE49-F238E27FC236}">
                <a16:creationId xmlns:a16="http://schemas.microsoft.com/office/drawing/2014/main" id="{F4F18E68-600A-4518-BFA9-EC5CEBDF7E9F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9075"/>
            <a:ext cx="12192000" cy="6419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701414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11D">
            <a:extLst>
              <a:ext uri="{FF2B5EF4-FFF2-40B4-BE49-F238E27FC236}">
                <a16:creationId xmlns:a16="http://schemas.microsoft.com/office/drawing/2014/main" id="{0DD9E263-7DD7-48B0-8962-B7309E0E6449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775"/>
            <a:ext cx="12192000" cy="6646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9641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2D">
            <a:extLst>
              <a:ext uri="{FF2B5EF4-FFF2-40B4-BE49-F238E27FC236}">
                <a16:creationId xmlns:a16="http://schemas.microsoft.com/office/drawing/2014/main" id="{C608DC71-384C-4B1A-8752-3D304E580212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6075"/>
            <a:ext cx="12192000" cy="6165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34995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3A">
            <a:extLst>
              <a:ext uri="{FF2B5EF4-FFF2-40B4-BE49-F238E27FC236}">
                <a16:creationId xmlns:a16="http://schemas.microsoft.com/office/drawing/2014/main" id="{B05B5CC5-9F68-4A5E-8748-7BF2D77525A5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463"/>
            <a:ext cx="12192000" cy="68214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2141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3B">
            <a:extLst>
              <a:ext uri="{FF2B5EF4-FFF2-40B4-BE49-F238E27FC236}">
                <a16:creationId xmlns:a16="http://schemas.microsoft.com/office/drawing/2014/main" id="{07CA7DDA-20A7-4D00-9DC8-B7167284B8B4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9725"/>
            <a:ext cx="12192000" cy="6178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95886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3C">
            <a:extLst>
              <a:ext uri="{FF2B5EF4-FFF2-40B4-BE49-F238E27FC236}">
                <a16:creationId xmlns:a16="http://schemas.microsoft.com/office/drawing/2014/main" id="{60F4BE88-EC2C-4C46-9D82-8E8F56BD74C6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7150"/>
            <a:ext cx="12192000" cy="674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44862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3D">
            <a:extLst>
              <a:ext uri="{FF2B5EF4-FFF2-40B4-BE49-F238E27FC236}">
                <a16:creationId xmlns:a16="http://schemas.microsoft.com/office/drawing/2014/main" id="{98B00E54-09B7-4C08-B8F3-2AC61A017D30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700"/>
            <a:ext cx="12192000" cy="68310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2068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4A">
            <a:extLst>
              <a:ext uri="{FF2B5EF4-FFF2-40B4-BE49-F238E27FC236}">
                <a16:creationId xmlns:a16="http://schemas.microsoft.com/office/drawing/2014/main" id="{2BF99478-44E9-44B0-B15D-4C3B000E3D1B}"/>
              </a:ext>
            </a:extLst>
          </p:cNvPr>
          <p:cNvPicPr>
            <a:picLocks noGrp="1" noChangeAspect="1"/>
          </p:cNvPicPr>
          <p:nvPr isPhoto="1"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5" y="0"/>
            <a:ext cx="121078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039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Widescreen</PresentationFormat>
  <Paragraphs>0</Paragraphs>
  <Slides>3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9</vt:i4>
      </vt:variant>
    </vt:vector>
  </HeadingPairs>
  <TitlesOfParts>
    <vt:vector size="4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H F</dc:creator>
  <cp:lastModifiedBy>DR. H F</cp:lastModifiedBy>
  <cp:revision>1</cp:revision>
  <dcterms:created xsi:type="dcterms:W3CDTF">2022-01-10T04:30:26Z</dcterms:created>
  <dcterms:modified xsi:type="dcterms:W3CDTF">2022-01-10T04:31:12Z</dcterms:modified>
</cp:coreProperties>
</file>